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7" r:id="rId2"/>
    <p:sldId id="269" r:id="rId3"/>
    <p:sldId id="270" r:id="rId4"/>
    <p:sldId id="271" r:id="rId5"/>
    <p:sldId id="272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sanne Gripenberg" userId="4a1a40c2-5968-4ce3-8c30-cc58d9f79c08" providerId="ADAL" clId="{0CF01436-4FF7-4591-BED8-A92CC09E2649}"/>
    <pc:docChg chg="custSel modSld">
      <pc:chgData name="Susanne Gripenberg" userId="4a1a40c2-5968-4ce3-8c30-cc58d9f79c08" providerId="ADAL" clId="{0CF01436-4FF7-4591-BED8-A92CC09E2649}" dt="2026-01-29T20:03:13.152" v="262" actId="167"/>
      <pc:docMkLst>
        <pc:docMk/>
      </pc:docMkLst>
      <pc:sldChg chg="addSp delSp modSp mod">
        <pc:chgData name="Susanne Gripenberg" userId="4a1a40c2-5968-4ce3-8c30-cc58d9f79c08" providerId="ADAL" clId="{0CF01436-4FF7-4591-BED8-A92CC09E2649}" dt="2026-01-29T20:01:54.111" v="183" actId="20577"/>
        <pc:sldMkLst>
          <pc:docMk/>
          <pc:sldMk cId="377290512" sldId="270"/>
        </pc:sldMkLst>
        <pc:spChg chg="mod">
          <ac:chgData name="Susanne Gripenberg" userId="4a1a40c2-5968-4ce3-8c30-cc58d9f79c08" providerId="ADAL" clId="{0CF01436-4FF7-4591-BED8-A92CC09E2649}" dt="2026-01-29T20:01:44.528" v="164" actId="20577"/>
          <ac:spMkLst>
            <pc:docMk/>
            <pc:sldMk cId="377290512" sldId="270"/>
            <ac:spMk id="7" creationId="{052C9DB1-A7E7-AFF9-69A7-650D7814FCD7}"/>
          </ac:spMkLst>
        </pc:spChg>
        <pc:spChg chg="mod">
          <ac:chgData name="Susanne Gripenberg" userId="4a1a40c2-5968-4ce3-8c30-cc58d9f79c08" providerId="ADAL" clId="{0CF01436-4FF7-4591-BED8-A92CC09E2649}" dt="2026-01-29T20:01:54.111" v="183" actId="20577"/>
          <ac:spMkLst>
            <pc:docMk/>
            <pc:sldMk cId="377290512" sldId="270"/>
            <ac:spMk id="24" creationId="{BEF84CFA-148B-CA85-B959-30A52BC846DE}"/>
          </ac:spMkLst>
        </pc:spChg>
        <pc:picChg chg="add mod">
          <ac:chgData name="Susanne Gripenberg" userId="4a1a40c2-5968-4ce3-8c30-cc58d9f79c08" providerId="ADAL" clId="{0CF01436-4FF7-4591-BED8-A92CC09E2649}" dt="2026-01-25T13:00:11.086" v="42" actId="1076"/>
          <ac:picMkLst>
            <pc:docMk/>
            <pc:sldMk cId="377290512" sldId="270"/>
            <ac:picMk id="10" creationId="{10A36F8A-95BC-DB9A-EFA3-E23207EB552F}"/>
          </ac:picMkLst>
        </pc:picChg>
        <pc:picChg chg="add mod">
          <ac:chgData name="Susanne Gripenberg" userId="4a1a40c2-5968-4ce3-8c30-cc58d9f79c08" providerId="ADAL" clId="{0CF01436-4FF7-4591-BED8-A92CC09E2649}" dt="2026-01-25T12:59:03.831" v="40" actId="14100"/>
          <ac:picMkLst>
            <pc:docMk/>
            <pc:sldMk cId="377290512" sldId="270"/>
            <ac:picMk id="14" creationId="{DA829C3D-746E-1E88-DFDC-8EEBF872DBF2}"/>
          </ac:picMkLst>
        </pc:picChg>
        <pc:picChg chg="add mod">
          <ac:chgData name="Susanne Gripenberg" userId="4a1a40c2-5968-4ce3-8c30-cc58d9f79c08" providerId="ADAL" clId="{0CF01436-4FF7-4591-BED8-A92CC09E2649}" dt="2026-01-25T13:01:55.166" v="54" actId="14100"/>
          <ac:picMkLst>
            <pc:docMk/>
            <pc:sldMk cId="377290512" sldId="270"/>
            <ac:picMk id="16" creationId="{DA897AFF-DE21-ED7E-19F8-90D2F33FB588}"/>
          </ac:picMkLst>
        </pc:picChg>
        <pc:picChg chg="add mod ord">
          <ac:chgData name="Susanne Gripenberg" userId="4a1a40c2-5968-4ce3-8c30-cc58d9f79c08" providerId="ADAL" clId="{0CF01436-4FF7-4591-BED8-A92CC09E2649}" dt="2026-01-25T13:22:52.253" v="145" actId="167"/>
          <ac:picMkLst>
            <pc:docMk/>
            <pc:sldMk cId="377290512" sldId="270"/>
            <ac:picMk id="23" creationId="{2A0270F3-9EB5-99DA-B589-D25B16CB9BFE}"/>
          </ac:picMkLst>
        </pc:picChg>
      </pc:sldChg>
      <pc:sldChg chg="modSp mod">
        <pc:chgData name="Susanne Gripenberg" userId="4a1a40c2-5968-4ce3-8c30-cc58d9f79c08" providerId="ADAL" clId="{0CF01436-4FF7-4591-BED8-A92CC09E2649}" dt="2026-01-29T20:02:13.121" v="221" actId="20577"/>
        <pc:sldMkLst>
          <pc:docMk/>
          <pc:sldMk cId="3021202674" sldId="271"/>
        </pc:sldMkLst>
        <pc:spChg chg="mod">
          <ac:chgData name="Susanne Gripenberg" userId="4a1a40c2-5968-4ce3-8c30-cc58d9f79c08" providerId="ADAL" clId="{0CF01436-4FF7-4591-BED8-A92CC09E2649}" dt="2026-01-29T20:02:04.813" v="202" actId="20577"/>
          <ac:spMkLst>
            <pc:docMk/>
            <pc:sldMk cId="3021202674" sldId="271"/>
            <ac:spMk id="11" creationId="{67B80BB0-9577-35DC-9F0E-53DB27DF2ABF}"/>
          </ac:spMkLst>
        </pc:spChg>
        <pc:spChg chg="mod">
          <ac:chgData name="Susanne Gripenberg" userId="4a1a40c2-5968-4ce3-8c30-cc58d9f79c08" providerId="ADAL" clId="{0CF01436-4FF7-4591-BED8-A92CC09E2649}" dt="2026-01-29T20:02:13.121" v="221" actId="20577"/>
          <ac:spMkLst>
            <pc:docMk/>
            <pc:sldMk cId="3021202674" sldId="271"/>
            <ac:spMk id="17" creationId="{A2DEEEB7-5B59-9DB7-EC13-022B12CDD6D8}"/>
          </ac:spMkLst>
        </pc:spChg>
      </pc:sldChg>
      <pc:sldChg chg="addSp delSp modSp mod">
        <pc:chgData name="Susanne Gripenberg" userId="4a1a40c2-5968-4ce3-8c30-cc58d9f79c08" providerId="ADAL" clId="{0CF01436-4FF7-4591-BED8-A92CC09E2649}" dt="2026-01-29T20:03:13.152" v="262" actId="167"/>
        <pc:sldMkLst>
          <pc:docMk/>
          <pc:sldMk cId="3633357330" sldId="272"/>
        </pc:sldMkLst>
        <pc:spChg chg="mod">
          <ac:chgData name="Susanne Gripenberg" userId="4a1a40c2-5968-4ce3-8c30-cc58d9f79c08" providerId="ADAL" clId="{0CF01436-4FF7-4591-BED8-A92CC09E2649}" dt="2026-01-29T20:02:23.636" v="240" actId="20577"/>
          <ac:spMkLst>
            <pc:docMk/>
            <pc:sldMk cId="3633357330" sldId="272"/>
            <ac:spMk id="3" creationId="{BB3E10A2-D3DF-1452-151F-D32787E36CA1}"/>
          </ac:spMkLst>
        </pc:spChg>
        <pc:spChg chg="mod">
          <ac:chgData name="Susanne Gripenberg" userId="4a1a40c2-5968-4ce3-8c30-cc58d9f79c08" providerId="ADAL" clId="{0CF01436-4FF7-4591-BED8-A92CC09E2649}" dt="2026-01-29T20:02:45.434" v="260" actId="20577"/>
          <ac:spMkLst>
            <pc:docMk/>
            <pc:sldMk cId="3633357330" sldId="272"/>
            <ac:spMk id="12" creationId="{73AD1CC8-E231-00B8-281B-9D506F7C756B}"/>
          </ac:spMkLst>
        </pc:spChg>
        <pc:picChg chg="add mod ord">
          <ac:chgData name="Susanne Gripenberg" userId="4a1a40c2-5968-4ce3-8c30-cc58d9f79c08" providerId="ADAL" clId="{0CF01436-4FF7-4591-BED8-A92CC09E2649}" dt="2026-01-29T20:03:13.152" v="262" actId="167"/>
          <ac:picMkLst>
            <pc:docMk/>
            <pc:sldMk cId="3633357330" sldId="272"/>
            <ac:picMk id="7" creationId="{BBB097DB-9047-4498-D279-C3B4678B4DCA}"/>
          </ac:picMkLst>
        </pc:picChg>
        <pc:picChg chg="add mod ord">
          <ac:chgData name="Susanne Gripenberg" userId="4a1a40c2-5968-4ce3-8c30-cc58d9f79c08" providerId="ADAL" clId="{0CF01436-4FF7-4591-BED8-A92CC09E2649}" dt="2026-01-25T13:18:11.613" v="131" actId="167"/>
          <ac:picMkLst>
            <pc:docMk/>
            <pc:sldMk cId="3633357330" sldId="272"/>
            <ac:picMk id="13" creationId="{F69A4660-A817-322A-06D7-78B03C7930DC}"/>
          </ac:picMkLst>
        </pc:picChg>
        <pc:picChg chg="add mod ord">
          <ac:chgData name="Susanne Gripenberg" userId="4a1a40c2-5968-4ce3-8c30-cc58d9f79c08" providerId="ADAL" clId="{0CF01436-4FF7-4591-BED8-A92CC09E2649}" dt="2026-01-25T13:13:09.052" v="109" actId="167"/>
          <ac:picMkLst>
            <pc:docMk/>
            <pc:sldMk cId="3633357330" sldId="272"/>
            <ac:picMk id="22" creationId="{80CC697F-7B9D-4404-5C55-0EC6042484F6}"/>
          </ac:picMkLst>
        </pc:picChg>
        <pc:picChg chg="add mod ord">
          <ac:chgData name="Susanne Gripenberg" userId="4a1a40c2-5968-4ce3-8c30-cc58d9f79c08" providerId="ADAL" clId="{0CF01436-4FF7-4591-BED8-A92CC09E2649}" dt="2026-01-25T13:17:50.249" v="130" actId="167"/>
          <ac:picMkLst>
            <pc:docMk/>
            <pc:sldMk cId="3633357330" sldId="272"/>
            <ac:picMk id="30" creationId="{19CBC027-67C2-5582-21BC-53EBF66D1DE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1F579A-81DC-4AF8-8615-1F2873CE2BDC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EA134F-4345-4856-A3F6-E914EF1EE48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94286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861B70-ED1A-42A7-BF2A-712A030F92A3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169477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861B70-ED1A-42A7-BF2A-712A030F92A3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411178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861B70-ED1A-42A7-BF2A-712A030F92A3}" type="slidenum">
              <a:rPr lang="sv-SE" smtClean="0"/>
              <a:t>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579603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861B70-ED1A-42A7-BF2A-712A030F92A3}" type="slidenum">
              <a:rPr lang="sv-SE" smtClean="0"/>
              <a:t>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1827511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861B70-ED1A-42A7-BF2A-712A030F92A3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141826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9A6CDBC-8585-ED90-A25C-4D553E3319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B554EEDF-5BDE-CD2E-12A1-6C75AD1EF2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EFB8703-3A15-88D2-4B22-0F4EAE1F4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255335B-0A32-4009-E5F1-C8065F875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6AA4317-7FE1-05CA-FEFF-D41E9781C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32122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58A6225-F74B-897F-81D3-83654378D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1EFAA508-DBE4-07E7-2368-BFC154EDFA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A43ABC3B-7E92-4E09-13B4-533680A3A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C597FD6-542D-3D0A-9FB6-25F1BF984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7E57AA4-1735-8863-4CD8-B5E928E59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60763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B6AE0B00-7002-9A56-BF09-4784B0F603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D5F926AC-D7E1-803A-0B77-065865602F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5225783-DFDE-75B6-4469-D8C2A12A2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3465FAC-0813-C6A6-C7EC-244D64DD4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A17E8AE-2A38-C7DB-61B7-6E10B2295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42781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01F92C6-B69B-8E57-0A72-657F42D5E4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8AAB9619-E36C-650B-5F2D-EA1539B91A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0205400-504E-1748-8F3D-267761240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A18D249-02B5-2705-8BF4-33FE1F595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1464149-4C2B-2B14-02CF-F989685D1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03249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DF509DB-22D2-C796-619C-E35817674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65DDD693-262B-311B-03B1-08F59BB299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2F10925-0568-FE51-3116-B9E5D5F59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30F0D65-3F78-6D63-2E35-29696B4C4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13CD512-6407-FDCF-52BA-06FE8194F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9331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934E924-558E-26CC-4EAB-E3DE27279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D62A1B8-639C-8706-21B6-9817CE384C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085F7227-F701-3364-524F-C8BAE37ABD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E399602-E1A3-C620-D6B4-4D46A7D36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72275EC-23A3-FE5D-0893-1F25F6B57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FF2D08C-546C-E14A-D8C9-3F8DC7FCE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70097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10908CF-8AD4-64FC-7D28-A2A4F5D27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2C2AB56-E24D-F902-96C1-E3E6A50DA9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8CB6F22C-1223-47F0-E6FA-3AC60E4116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815AC87C-0D75-1660-10E9-30C2E5C60F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C7B638D4-4165-D3B0-A304-D1C649544C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29DCDEE5-108D-A5FC-315B-458F7DD1A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B1EB9C50-DC96-3919-FAD5-D00F773F2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2B060D0F-75A5-AE2C-9C8A-F72345745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22747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3A7AD05-4119-4E04-E489-98D288DAB2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578B19B6-AE52-42DC-45F7-83C7ACE50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9A224585-3DC9-5E38-184B-4A1C62E55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EF0602BE-3F96-2D30-A585-3F76D1B95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6167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11C35358-245C-7E0E-A75F-B4FFA5107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C3D7F0F3-7B07-00E6-2633-083D25B25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616A50E7-48CA-4054-9819-2B06BF691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30546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F96ED48-E8CF-E0B6-639A-B76F73904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538A6DB6-9A52-B795-1C92-438027A8A2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9CC9617F-347E-B40D-7610-16DAD6A08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F42D49D-D63C-8E42-F6E5-0BF86738F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421205F0-43DA-A466-8304-52C3A8E61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79533164-5C4A-203A-6522-CFCE80E92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31757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C20E75D-0D29-FBE0-D2E6-451D4B431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B8E84EDF-2E19-EB1A-A9F6-8551813665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F5DA29FC-97BA-B95C-E705-CA4CC20452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0D112C0A-D87F-DD0B-7655-3AF990149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E8AEC713-DC77-541A-0BA8-9C4F41CB4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F53093F-9DF6-04E1-FA4B-8B59FB279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9859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DDF12130-4224-F736-16BB-AC6DB27303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524FFE39-00D9-73AA-3E8E-25D081DF6B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4998C9D-00A5-EDE5-6669-C16BAE296C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41A484-946D-4ECB-BF0F-D5CFBE68F218}" type="datetimeFigureOut">
              <a:rPr lang="sv-SE" smtClean="0"/>
              <a:t>2026-01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0B26B2A-3613-862A-C62D-DDD2B8DADF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92274BC-1BB1-D50C-6AAF-27D1373CE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D88469-9A20-4976-AE40-44B2A1F4799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24711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62ED1384-CD07-C77E-EEE4-7166B636800E}"/>
              </a:ext>
            </a:extLst>
          </p:cNvPr>
          <p:cNvSpPr txBox="1"/>
          <p:nvPr/>
        </p:nvSpPr>
        <p:spPr>
          <a:xfrm>
            <a:off x="2812330" y="1461323"/>
            <a:ext cx="6096000" cy="29219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.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ltin-Grimby Physical Activity Level Scale (SGPALS)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“How much do you move and exert yourself physically during your leisure time?”</a:t>
            </a:r>
            <a:endParaRPr lang="en-US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swer options: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 Physically inactive </a:t>
            </a: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 Some light physical activity</a:t>
            </a: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. Regular physical activity and training</a:t>
            </a: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 Regular hard physical training for competitive sports.</a:t>
            </a:r>
          </a:p>
          <a:p>
            <a:pPr>
              <a:lnSpc>
                <a:spcPct val="150000"/>
              </a:lnSpc>
            </a:pP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ruta 1">
            <a:extLst>
              <a:ext uri="{FF2B5EF4-FFF2-40B4-BE49-F238E27FC236}">
                <a16:creationId xmlns:a16="http://schemas.microsoft.com/office/drawing/2014/main" id="{AF54014D-DFE1-5C1C-7929-E08EA1A2B47C}"/>
              </a:ext>
            </a:extLst>
          </p:cNvPr>
          <p:cNvSpPr txBox="1"/>
          <p:nvPr/>
        </p:nvSpPr>
        <p:spPr>
          <a:xfrm>
            <a:off x="2815473" y="3905389"/>
            <a:ext cx="5866614" cy="280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estion and answer options from </a:t>
            </a:r>
            <a:r>
              <a:rPr lang="en-US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ltin-Grimby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ysical Activity Level Scale (SGPALS)</a:t>
            </a:r>
            <a:endParaRPr lang="sv-SE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9288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5B8DB32F-0739-7B1C-7582-276C254A7F8F}"/>
              </a:ext>
            </a:extLst>
          </p:cNvPr>
          <p:cNvSpPr txBox="1"/>
          <p:nvPr/>
        </p:nvSpPr>
        <p:spPr>
          <a:xfrm>
            <a:off x="3048000" y="842733"/>
            <a:ext cx="6096000" cy="4664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2. </a:t>
            </a:r>
          </a:p>
          <a:p>
            <a:pPr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ient-reported questions </a:t>
            </a:r>
            <a:r>
              <a:rPr lang="sv-SE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 What activities do you perform in your spare time? 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ree text)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 Please tell us if you think you have any difficulties with certain physical activities? (Free text)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How often do you usually participate in physical education and health in school?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swer options: Always, Often, Sometimes, Seldom, Never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. Please describe if there is anything you avoid doing in 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ysical education and health in school? (Free text)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. Please describe if there is anything that you think is difficult in physical education and health in school? (Free text)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.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w do you find your balance compared to others in your age?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swer options: Much better, A little better, Like others, A little worse, Much worse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. Do you know if you learned any of the following late?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cycle, Walk, Sit: 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swer options: Learned late, Learned like others, Don't know</a:t>
            </a:r>
            <a:endParaRPr lang="sv-SE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sv-SE" sz="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sv-S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ruta 1">
            <a:extLst>
              <a:ext uri="{FF2B5EF4-FFF2-40B4-BE49-F238E27FC236}">
                <a16:creationId xmlns:a16="http://schemas.microsoft.com/office/drawing/2014/main" id="{B0804D44-7C0B-5AA1-DC49-09A2EAD9A1BE}"/>
              </a:ext>
            </a:extLst>
          </p:cNvPr>
          <p:cNvSpPr txBox="1"/>
          <p:nvPr/>
        </p:nvSpPr>
        <p:spPr>
          <a:xfrm>
            <a:off x="3120271" y="5317682"/>
            <a:ext cx="4581427" cy="8731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questionnaire with patient-reported questions on experience of physical activity, balance, participation in physical education in school and motor development, and answer options/ free text option. Constructed by the authors in collaboration with local expertise.</a:t>
            </a:r>
            <a:endParaRPr lang="sv-SE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3131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Bildobjekt 22" descr="En bild som visar text, diagram, skärmbild, linje">
            <a:extLst>
              <a:ext uri="{FF2B5EF4-FFF2-40B4-BE49-F238E27FC236}">
                <a16:creationId xmlns:a16="http://schemas.microsoft.com/office/drawing/2014/main" id="{2A0270F3-9EB5-99DA-B589-D25B16CB9B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3290" y="3375174"/>
            <a:ext cx="4483069" cy="2903927"/>
          </a:xfrm>
          <a:prstGeom prst="rect">
            <a:avLst/>
          </a:prstGeom>
        </p:spPr>
      </p:pic>
      <p:sp>
        <p:nvSpPr>
          <p:cNvPr id="18" name="textruta 17">
            <a:extLst>
              <a:ext uri="{FF2B5EF4-FFF2-40B4-BE49-F238E27FC236}">
                <a16:creationId xmlns:a16="http://schemas.microsoft.com/office/drawing/2014/main" id="{5739E51E-336F-C724-E1AE-F220EB03BD37}"/>
              </a:ext>
            </a:extLst>
          </p:cNvPr>
          <p:cNvSpPr txBox="1"/>
          <p:nvPr/>
        </p:nvSpPr>
        <p:spPr>
          <a:xfrm>
            <a:off x="837082" y="348065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20" name="textruta 19">
            <a:extLst>
              <a:ext uri="{FF2B5EF4-FFF2-40B4-BE49-F238E27FC236}">
                <a16:creationId xmlns:a16="http://schemas.microsoft.com/office/drawing/2014/main" id="{65300631-42BD-BFFF-978A-641CFD08BBD6}"/>
              </a:ext>
            </a:extLst>
          </p:cNvPr>
          <p:cNvSpPr txBox="1"/>
          <p:nvPr/>
        </p:nvSpPr>
        <p:spPr>
          <a:xfrm>
            <a:off x="6174494" y="34806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21" name="textruta 20">
            <a:extLst>
              <a:ext uri="{FF2B5EF4-FFF2-40B4-BE49-F238E27FC236}">
                <a16:creationId xmlns:a16="http://schemas.microsoft.com/office/drawing/2014/main" id="{4817241F-E39F-2A0B-2875-3EE1025754A8}"/>
              </a:ext>
            </a:extLst>
          </p:cNvPr>
          <p:cNvSpPr txBox="1"/>
          <p:nvPr/>
        </p:nvSpPr>
        <p:spPr>
          <a:xfrm>
            <a:off x="832803" y="2924324"/>
            <a:ext cx="377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22" name="textruta 21">
            <a:extLst>
              <a:ext uri="{FF2B5EF4-FFF2-40B4-BE49-F238E27FC236}">
                <a16:creationId xmlns:a16="http://schemas.microsoft.com/office/drawing/2014/main" id="{FF345D83-E7C5-4C1B-8D83-4605D9AE9222}"/>
              </a:ext>
            </a:extLst>
          </p:cNvPr>
          <p:cNvSpPr txBox="1"/>
          <p:nvPr/>
        </p:nvSpPr>
        <p:spPr>
          <a:xfrm>
            <a:off x="6174494" y="3000374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sp>
        <p:nvSpPr>
          <p:cNvPr id="24" name="textruta 23">
            <a:extLst>
              <a:ext uri="{FF2B5EF4-FFF2-40B4-BE49-F238E27FC236}">
                <a16:creationId xmlns:a16="http://schemas.microsoft.com/office/drawing/2014/main" id="{BEF84CFA-148B-CA85-B959-30A52BC846DE}"/>
              </a:ext>
            </a:extLst>
          </p:cNvPr>
          <p:cNvSpPr txBox="1"/>
          <p:nvPr/>
        </p:nvSpPr>
        <p:spPr>
          <a:xfrm>
            <a:off x="1748414" y="5863603"/>
            <a:ext cx="85823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anc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acity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Cochlear Implants (CI) on and off in teenagers and young adults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rmal hearing (NH), n=20, and teenagers and young adults with CI (TAYACI), n=41, in a) item BOT4 from 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uininks-Oseretsky Test of Motor Proficiency (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-2), b) item BOT6 from BOT-2, c) item BOT9 from BOT-2 and d) item 19d from </a:t>
            </a:r>
            <a:r>
              <a:rPr lang="sv-SE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ds-</a:t>
            </a:r>
            <a:r>
              <a:rPr lang="sv-SE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anc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valuation System Test</a:t>
            </a:r>
            <a:r>
              <a:rPr lang="sv-SE" sz="12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s-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STest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ime in seconds.</a:t>
            </a:r>
          </a:p>
        </p:txBody>
      </p:sp>
      <p:grpSp>
        <p:nvGrpSpPr>
          <p:cNvPr id="6" name="Grupp 5">
            <a:extLst>
              <a:ext uri="{FF2B5EF4-FFF2-40B4-BE49-F238E27FC236}">
                <a16:creationId xmlns:a16="http://schemas.microsoft.com/office/drawing/2014/main" id="{0338E189-D0D0-17CB-6A79-B7CEA220107D}"/>
              </a:ext>
            </a:extLst>
          </p:cNvPr>
          <p:cNvGrpSpPr/>
          <p:nvPr/>
        </p:nvGrpSpPr>
        <p:grpSpPr>
          <a:xfrm>
            <a:off x="1862414" y="2968949"/>
            <a:ext cx="2248920" cy="468517"/>
            <a:chOff x="1862414" y="2968949"/>
            <a:chExt cx="2248920" cy="468517"/>
          </a:xfrm>
        </p:grpSpPr>
        <p:sp>
          <p:nvSpPr>
            <p:cNvPr id="2" name="Vänster hakparentes 1">
              <a:extLst>
                <a:ext uri="{FF2B5EF4-FFF2-40B4-BE49-F238E27FC236}">
                  <a16:creationId xmlns:a16="http://schemas.microsoft.com/office/drawing/2014/main" id="{1AC97A33-144C-CB92-56EB-796B97B78EB1}"/>
                </a:ext>
              </a:extLst>
            </p:cNvPr>
            <p:cNvSpPr/>
            <p:nvPr/>
          </p:nvSpPr>
          <p:spPr>
            <a:xfrm rot="5400000">
              <a:off x="2116573" y="3064594"/>
              <a:ext cx="110249" cy="618567"/>
            </a:xfrm>
            <a:prstGeom prst="leftBracket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Vänster hakparentes 2">
              <a:extLst>
                <a:ext uri="{FF2B5EF4-FFF2-40B4-BE49-F238E27FC236}">
                  <a16:creationId xmlns:a16="http://schemas.microsoft.com/office/drawing/2014/main" id="{94B1C0D7-9E1C-24D7-DFA6-918F0E23669E}"/>
                </a:ext>
              </a:extLst>
            </p:cNvPr>
            <p:cNvSpPr/>
            <p:nvPr/>
          </p:nvSpPr>
          <p:spPr>
            <a:xfrm rot="5400000">
              <a:off x="3752262" y="3078395"/>
              <a:ext cx="126473" cy="591670"/>
            </a:xfrm>
            <a:prstGeom prst="leftBracket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" name="Vänster hakparentes 3">
              <a:extLst>
                <a:ext uri="{FF2B5EF4-FFF2-40B4-BE49-F238E27FC236}">
                  <a16:creationId xmlns:a16="http://schemas.microsoft.com/office/drawing/2014/main" id="{F6F4EDE4-7C18-8B6A-F490-A12A375E44E1}"/>
                </a:ext>
              </a:extLst>
            </p:cNvPr>
            <p:cNvSpPr/>
            <p:nvPr/>
          </p:nvSpPr>
          <p:spPr>
            <a:xfrm rot="5400000">
              <a:off x="2932604" y="2394222"/>
              <a:ext cx="126473" cy="1686587"/>
            </a:xfrm>
            <a:prstGeom prst="leftBracket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textruta 4">
              <a:extLst>
                <a:ext uri="{FF2B5EF4-FFF2-40B4-BE49-F238E27FC236}">
                  <a16:creationId xmlns:a16="http://schemas.microsoft.com/office/drawing/2014/main" id="{863F83AB-0F09-B562-E0C7-C7B3E821968E}"/>
                </a:ext>
              </a:extLst>
            </p:cNvPr>
            <p:cNvSpPr txBox="1"/>
            <p:nvPr/>
          </p:nvSpPr>
          <p:spPr>
            <a:xfrm>
              <a:off x="2830607" y="2968949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***</a:t>
              </a:r>
            </a:p>
          </p:txBody>
        </p:sp>
      </p:grpSp>
      <p:sp>
        <p:nvSpPr>
          <p:cNvPr id="7" name="textruta 6">
            <a:extLst>
              <a:ext uri="{FF2B5EF4-FFF2-40B4-BE49-F238E27FC236}">
                <a16:creationId xmlns:a16="http://schemas.microsoft.com/office/drawing/2014/main" id="{052C9DB1-A7E7-AFF9-69A7-650D7814FCD7}"/>
              </a:ext>
            </a:extLst>
          </p:cNvPr>
          <p:cNvSpPr txBox="1"/>
          <p:nvPr/>
        </p:nvSpPr>
        <p:spPr>
          <a:xfrm>
            <a:off x="916218" y="92136"/>
            <a:ext cx="5258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dditional file 6. Balance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apacity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with CI on and off in NH and TAYACI</a:t>
            </a:r>
            <a:endParaRPr lang="sv-SE" sz="1200" dirty="0"/>
          </a:p>
        </p:txBody>
      </p:sp>
      <p:pic>
        <p:nvPicPr>
          <p:cNvPr id="10" name="Bildobjekt 9" descr="En bild som visar text, skärmbild, diagram, linje">
            <a:extLst>
              <a:ext uri="{FF2B5EF4-FFF2-40B4-BE49-F238E27FC236}">
                <a16:creationId xmlns:a16="http://schemas.microsoft.com/office/drawing/2014/main" id="{10A36F8A-95BC-DB9A-EFA3-E23207EB55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8723" y="376894"/>
            <a:ext cx="4592205" cy="2974620"/>
          </a:xfrm>
          <a:prstGeom prst="rect">
            <a:avLst/>
          </a:prstGeom>
        </p:spPr>
      </p:pic>
      <p:pic>
        <p:nvPicPr>
          <p:cNvPr id="14" name="Bildobjekt 13" descr="En bild som visar text, diagram, skärmbild, linje">
            <a:extLst>
              <a:ext uri="{FF2B5EF4-FFF2-40B4-BE49-F238E27FC236}">
                <a16:creationId xmlns:a16="http://schemas.microsoft.com/office/drawing/2014/main" id="{DA829C3D-746E-1E88-DFDC-8EEBF872DB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01158" y="369535"/>
            <a:ext cx="4583136" cy="2968746"/>
          </a:xfrm>
          <a:prstGeom prst="rect">
            <a:avLst/>
          </a:prstGeom>
        </p:spPr>
      </p:pic>
      <p:pic>
        <p:nvPicPr>
          <p:cNvPr id="16" name="Bildobjekt 15" descr="En bild som visar text, skärmbild, linje, nummer">
            <a:extLst>
              <a:ext uri="{FF2B5EF4-FFF2-40B4-BE49-F238E27FC236}">
                <a16:creationId xmlns:a16="http://schemas.microsoft.com/office/drawing/2014/main" id="{DA897AFF-DE21-ED7E-19F8-90D2F33FB5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46643" y="3277374"/>
            <a:ext cx="4363360" cy="28227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290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ruta 16">
            <a:extLst>
              <a:ext uri="{FF2B5EF4-FFF2-40B4-BE49-F238E27FC236}">
                <a16:creationId xmlns:a16="http://schemas.microsoft.com/office/drawing/2014/main" id="{A2DEEEB7-5B59-9DB7-EC13-022B12CDD6D8}"/>
              </a:ext>
            </a:extLst>
          </p:cNvPr>
          <p:cNvSpPr txBox="1"/>
          <p:nvPr/>
        </p:nvSpPr>
        <p:spPr>
          <a:xfrm>
            <a:off x="2300510" y="5864028"/>
            <a:ext cx="72650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anc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acity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Cochlear Implants (CI) on and off in teenagers and young adults with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ormal vestibular function (NVF), n=39, and with cochlear implants and vestibular </a:t>
            </a:r>
            <a:r>
              <a:rPr lang="en-US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irment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VL), 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8, in a) item BOT4 from 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uininks-Oseretsky Test of Motor Proficiency (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-2), b) item BOT6 from BOT-2, c) item BOT9 from BOT-2 and d) item 19d from </a:t>
            </a:r>
            <a:r>
              <a:rPr lang="sv-SE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ds-</a:t>
            </a:r>
            <a:r>
              <a:rPr lang="sv-SE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anc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valuation System Test</a:t>
            </a:r>
            <a:r>
              <a:rPr lang="sv-SE" sz="12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s-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STest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ime in seconds.</a:t>
            </a:r>
          </a:p>
        </p:txBody>
      </p:sp>
      <p:grpSp>
        <p:nvGrpSpPr>
          <p:cNvPr id="19" name="Grupp 18">
            <a:extLst>
              <a:ext uri="{FF2B5EF4-FFF2-40B4-BE49-F238E27FC236}">
                <a16:creationId xmlns:a16="http://schemas.microsoft.com/office/drawing/2014/main" id="{C004020A-C968-EEDD-0DFC-C86A46938032}"/>
              </a:ext>
            </a:extLst>
          </p:cNvPr>
          <p:cNvGrpSpPr/>
          <p:nvPr/>
        </p:nvGrpSpPr>
        <p:grpSpPr>
          <a:xfrm>
            <a:off x="697960" y="3034971"/>
            <a:ext cx="4142469" cy="2857859"/>
            <a:chOff x="737235" y="3157213"/>
            <a:chExt cx="4142469" cy="2857859"/>
          </a:xfrm>
        </p:grpSpPr>
        <p:grpSp>
          <p:nvGrpSpPr>
            <p:cNvPr id="10" name="Grupp 9">
              <a:extLst>
                <a:ext uri="{FF2B5EF4-FFF2-40B4-BE49-F238E27FC236}">
                  <a16:creationId xmlns:a16="http://schemas.microsoft.com/office/drawing/2014/main" id="{EE922247-AD16-5D7D-500A-746E7E04563D}"/>
                </a:ext>
              </a:extLst>
            </p:cNvPr>
            <p:cNvGrpSpPr/>
            <p:nvPr/>
          </p:nvGrpSpPr>
          <p:grpSpPr>
            <a:xfrm>
              <a:off x="1371592" y="3157213"/>
              <a:ext cx="2248920" cy="468517"/>
              <a:chOff x="1862414" y="2968949"/>
              <a:chExt cx="2248920" cy="468517"/>
            </a:xfrm>
          </p:grpSpPr>
          <p:sp>
            <p:nvSpPr>
              <p:cNvPr id="13" name="Vänster hakparentes 12">
                <a:extLst>
                  <a:ext uri="{FF2B5EF4-FFF2-40B4-BE49-F238E27FC236}">
                    <a16:creationId xmlns:a16="http://schemas.microsoft.com/office/drawing/2014/main" id="{3DB8CCE3-9C35-13DC-CE80-C00D81CB5CD1}"/>
                  </a:ext>
                </a:extLst>
              </p:cNvPr>
              <p:cNvSpPr/>
              <p:nvPr/>
            </p:nvSpPr>
            <p:spPr>
              <a:xfrm rot="5400000">
                <a:off x="2116573" y="3064594"/>
                <a:ext cx="110249" cy="618567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Vänster hakparentes 13">
                <a:extLst>
                  <a:ext uri="{FF2B5EF4-FFF2-40B4-BE49-F238E27FC236}">
                    <a16:creationId xmlns:a16="http://schemas.microsoft.com/office/drawing/2014/main" id="{C6B918A9-5977-88BF-8E11-DDEBB7CFFEE8}"/>
                  </a:ext>
                </a:extLst>
              </p:cNvPr>
              <p:cNvSpPr/>
              <p:nvPr/>
            </p:nvSpPr>
            <p:spPr>
              <a:xfrm rot="5400000">
                <a:off x="3752262" y="3078395"/>
                <a:ext cx="126473" cy="591670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Vänster hakparentes 14">
                <a:extLst>
                  <a:ext uri="{FF2B5EF4-FFF2-40B4-BE49-F238E27FC236}">
                    <a16:creationId xmlns:a16="http://schemas.microsoft.com/office/drawing/2014/main" id="{FCE5F924-1DD5-21E2-BEA3-38CE0915AE84}"/>
                  </a:ext>
                </a:extLst>
              </p:cNvPr>
              <p:cNvSpPr/>
              <p:nvPr/>
            </p:nvSpPr>
            <p:spPr>
              <a:xfrm rot="5400000">
                <a:off x="2932604" y="2394222"/>
                <a:ext cx="126473" cy="1686587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textruta 15">
                <a:extLst>
                  <a:ext uri="{FF2B5EF4-FFF2-40B4-BE49-F238E27FC236}">
                    <a16:creationId xmlns:a16="http://schemas.microsoft.com/office/drawing/2014/main" id="{A17005C9-C26C-2F23-A63C-FC9D28226B25}"/>
                  </a:ext>
                </a:extLst>
              </p:cNvPr>
              <p:cNvSpPr txBox="1"/>
              <p:nvPr/>
            </p:nvSpPr>
            <p:spPr>
              <a:xfrm>
                <a:off x="2830607" y="2968949"/>
                <a:ext cx="5020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***</a:t>
                </a:r>
              </a:p>
            </p:txBody>
          </p:sp>
        </p:grpSp>
        <p:pic>
          <p:nvPicPr>
            <p:cNvPr id="18" name="Bildobjekt 17">
              <a:extLst>
                <a:ext uri="{FF2B5EF4-FFF2-40B4-BE49-F238E27FC236}">
                  <a16:creationId xmlns:a16="http://schemas.microsoft.com/office/drawing/2014/main" id="{A0BB3C9F-A3B8-3FD0-D2E5-22337270D3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7235" y="3580334"/>
              <a:ext cx="4142469" cy="2434738"/>
            </a:xfrm>
            <a:prstGeom prst="rect">
              <a:avLst/>
            </a:prstGeom>
          </p:spPr>
        </p:pic>
      </p:grpSp>
      <p:pic>
        <p:nvPicPr>
          <p:cNvPr id="20" name="Bildobjekt 19">
            <a:extLst>
              <a:ext uri="{FF2B5EF4-FFF2-40B4-BE49-F238E27FC236}">
                <a16:creationId xmlns:a16="http://schemas.microsoft.com/office/drawing/2014/main" id="{D287622E-8378-ADB7-587F-FFEE9B8B70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7960" y="437310"/>
            <a:ext cx="4307465" cy="2720209"/>
          </a:xfrm>
          <a:prstGeom prst="rect">
            <a:avLst/>
          </a:prstGeom>
        </p:spPr>
      </p:pic>
      <p:grpSp>
        <p:nvGrpSpPr>
          <p:cNvPr id="22" name="Grupp 21">
            <a:extLst>
              <a:ext uri="{FF2B5EF4-FFF2-40B4-BE49-F238E27FC236}">
                <a16:creationId xmlns:a16="http://schemas.microsoft.com/office/drawing/2014/main" id="{A2EE6F38-7425-65A6-4BCD-79911C7AD90D}"/>
              </a:ext>
            </a:extLst>
          </p:cNvPr>
          <p:cNvGrpSpPr/>
          <p:nvPr/>
        </p:nvGrpSpPr>
        <p:grpSpPr>
          <a:xfrm>
            <a:off x="6471920" y="36208"/>
            <a:ext cx="4781995" cy="3122463"/>
            <a:chOff x="6307930" y="326605"/>
            <a:chExt cx="4781995" cy="3122463"/>
          </a:xfrm>
        </p:grpSpPr>
        <p:grpSp>
          <p:nvGrpSpPr>
            <p:cNvPr id="2" name="Grupp 1">
              <a:extLst>
                <a:ext uri="{FF2B5EF4-FFF2-40B4-BE49-F238E27FC236}">
                  <a16:creationId xmlns:a16="http://schemas.microsoft.com/office/drawing/2014/main" id="{1ED868DF-D336-F28C-CEA2-D7EDB50B4B2C}"/>
                </a:ext>
              </a:extLst>
            </p:cNvPr>
            <p:cNvGrpSpPr/>
            <p:nvPr/>
          </p:nvGrpSpPr>
          <p:grpSpPr>
            <a:xfrm>
              <a:off x="7194156" y="326605"/>
              <a:ext cx="2248920" cy="468517"/>
              <a:chOff x="1862414" y="2968949"/>
              <a:chExt cx="2248920" cy="468517"/>
            </a:xfrm>
          </p:grpSpPr>
          <p:sp>
            <p:nvSpPr>
              <p:cNvPr id="3" name="Vänster hakparentes 2">
                <a:extLst>
                  <a:ext uri="{FF2B5EF4-FFF2-40B4-BE49-F238E27FC236}">
                    <a16:creationId xmlns:a16="http://schemas.microsoft.com/office/drawing/2014/main" id="{D60A1524-AD00-08E7-F623-AB67E939AA4E}"/>
                  </a:ext>
                </a:extLst>
              </p:cNvPr>
              <p:cNvSpPr/>
              <p:nvPr/>
            </p:nvSpPr>
            <p:spPr>
              <a:xfrm rot="5400000">
                <a:off x="2116573" y="3064594"/>
                <a:ext cx="110249" cy="618567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" name="Vänster hakparentes 3">
                <a:extLst>
                  <a:ext uri="{FF2B5EF4-FFF2-40B4-BE49-F238E27FC236}">
                    <a16:creationId xmlns:a16="http://schemas.microsoft.com/office/drawing/2014/main" id="{64E49A7D-5C9E-6EED-2AE5-8AA8420B48CE}"/>
                  </a:ext>
                </a:extLst>
              </p:cNvPr>
              <p:cNvSpPr/>
              <p:nvPr/>
            </p:nvSpPr>
            <p:spPr>
              <a:xfrm rot="5400000">
                <a:off x="3752262" y="3078395"/>
                <a:ext cx="126473" cy="591670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" name="Vänster hakparentes 5">
                <a:extLst>
                  <a:ext uri="{FF2B5EF4-FFF2-40B4-BE49-F238E27FC236}">
                    <a16:creationId xmlns:a16="http://schemas.microsoft.com/office/drawing/2014/main" id="{3F86E79D-EC5E-19C7-145F-87548E845AF8}"/>
                  </a:ext>
                </a:extLst>
              </p:cNvPr>
              <p:cNvSpPr/>
              <p:nvPr/>
            </p:nvSpPr>
            <p:spPr>
              <a:xfrm rot="5400000">
                <a:off x="2932604" y="2394222"/>
                <a:ext cx="126473" cy="1686587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textruta 7">
                <a:extLst>
                  <a:ext uri="{FF2B5EF4-FFF2-40B4-BE49-F238E27FC236}">
                    <a16:creationId xmlns:a16="http://schemas.microsoft.com/office/drawing/2014/main" id="{60285F2B-2CF3-7445-83A0-00933A310FCB}"/>
                  </a:ext>
                </a:extLst>
              </p:cNvPr>
              <p:cNvSpPr txBox="1"/>
              <p:nvPr/>
            </p:nvSpPr>
            <p:spPr>
              <a:xfrm>
                <a:off x="2830607" y="2968949"/>
                <a:ext cx="3962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**</a:t>
                </a:r>
              </a:p>
            </p:txBody>
          </p:sp>
        </p:grpSp>
        <p:pic>
          <p:nvPicPr>
            <p:cNvPr id="21" name="Bildobjekt 20">
              <a:extLst>
                <a:ext uri="{FF2B5EF4-FFF2-40B4-BE49-F238E27FC236}">
                  <a16:creationId xmlns:a16="http://schemas.microsoft.com/office/drawing/2014/main" id="{B76C73FA-40B3-2453-262B-394D3A179B4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07930" y="633816"/>
              <a:ext cx="4781995" cy="2815252"/>
            </a:xfrm>
            <a:prstGeom prst="rect">
              <a:avLst/>
            </a:prstGeom>
          </p:spPr>
        </p:pic>
      </p:grpSp>
      <p:sp>
        <p:nvSpPr>
          <p:cNvPr id="24" name="textruta 23">
            <a:extLst>
              <a:ext uri="{FF2B5EF4-FFF2-40B4-BE49-F238E27FC236}">
                <a16:creationId xmlns:a16="http://schemas.microsoft.com/office/drawing/2014/main" id="{F34E84B4-76FE-917D-03F3-2C360E27CC91}"/>
              </a:ext>
            </a:extLst>
          </p:cNvPr>
          <p:cNvSpPr txBox="1"/>
          <p:nvPr/>
        </p:nvSpPr>
        <p:spPr>
          <a:xfrm>
            <a:off x="386876" y="455375"/>
            <a:ext cx="311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25" name="textruta 24">
            <a:extLst>
              <a:ext uri="{FF2B5EF4-FFF2-40B4-BE49-F238E27FC236}">
                <a16:creationId xmlns:a16="http://schemas.microsoft.com/office/drawing/2014/main" id="{62E1976B-41FA-A3EC-4621-AB331E01C0EC}"/>
              </a:ext>
            </a:extLst>
          </p:cNvPr>
          <p:cNvSpPr txBox="1"/>
          <p:nvPr/>
        </p:nvSpPr>
        <p:spPr>
          <a:xfrm>
            <a:off x="6044107" y="45537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26" name="textruta 25">
            <a:extLst>
              <a:ext uri="{FF2B5EF4-FFF2-40B4-BE49-F238E27FC236}">
                <a16:creationId xmlns:a16="http://schemas.microsoft.com/office/drawing/2014/main" id="{20D86C55-F5D0-6C8D-09DA-27A45DE311F0}"/>
              </a:ext>
            </a:extLst>
          </p:cNvPr>
          <p:cNvSpPr txBox="1"/>
          <p:nvPr/>
        </p:nvSpPr>
        <p:spPr>
          <a:xfrm>
            <a:off x="393068" y="3303538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27" name="textruta 26">
            <a:extLst>
              <a:ext uri="{FF2B5EF4-FFF2-40B4-BE49-F238E27FC236}">
                <a16:creationId xmlns:a16="http://schemas.microsoft.com/office/drawing/2014/main" id="{A5922E19-A5CA-2941-7816-EF808D49F8FC}"/>
              </a:ext>
            </a:extLst>
          </p:cNvPr>
          <p:cNvSpPr txBox="1"/>
          <p:nvPr/>
        </p:nvSpPr>
        <p:spPr>
          <a:xfrm>
            <a:off x="6044107" y="32905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sp>
        <p:nvSpPr>
          <p:cNvPr id="5" name="Vänster hakparentes 4">
            <a:extLst>
              <a:ext uri="{FF2B5EF4-FFF2-40B4-BE49-F238E27FC236}">
                <a16:creationId xmlns:a16="http://schemas.microsoft.com/office/drawing/2014/main" id="{86951281-7DE9-7865-EDF3-332A6839905A}"/>
              </a:ext>
            </a:extLst>
          </p:cNvPr>
          <p:cNvSpPr/>
          <p:nvPr/>
        </p:nvSpPr>
        <p:spPr>
          <a:xfrm rot="5400000">
            <a:off x="9028846" y="3081180"/>
            <a:ext cx="126473" cy="59167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9" name="Grupp 8">
            <a:extLst>
              <a:ext uri="{FF2B5EF4-FFF2-40B4-BE49-F238E27FC236}">
                <a16:creationId xmlns:a16="http://schemas.microsoft.com/office/drawing/2014/main" id="{52EDCEE8-5A25-C34C-F949-183613DA8B73}"/>
              </a:ext>
            </a:extLst>
          </p:cNvPr>
          <p:cNvGrpSpPr/>
          <p:nvPr/>
        </p:nvGrpSpPr>
        <p:grpSpPr>
          <a:xfrm>
            <a:off x="6515729" y="3085009"/>
            <a:ext cx="4413743" cy="2851530"/>
            <a:chOff x="6515729" y="3088760"/>
            <a:chExt cx="4413743" cy="2851530"/>
          </a:xfrm>
        </p:grpSpPr>
        <p:pic>
          <p:nvPicPr>
            <p:cNvPr id="23" name="Bildobjekt 22">
              <a:extLst>
                <a:ext uri="{FF2B5EF4-FFF2-40B4-BE49-F238E27FC236}">
                  <a16:creationId xmlns:a16="http://schemas.microsoft.com/office/drawing/2014/main" id="{C8049DAA-2D07-601F-B602-E3247E47346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15729" y="3346111"/>
              <a:ext cx="4413743" cy="2594179"/>
            </a:xfrm>
            <a:prstGeom prst="rect">
              <a:avLst/>
            </a:prstGeom>
          </p:spPr>
        </p:pic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EED58F82-F91A-9AB6-FEF1-1A5D74C7B4AF}"/>
                </a:ext>
              </a:extLst>
            </p:cNvPr>
            <p:cNvSpPr txBox="1"/>
            <p:nvPr/>
          </p:nvSpPr>
          <p:spPr>
            <a:xfrm>
              <a:off x="8827595" y="3088760"/>
              <a:ext cx="574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***</a:t>
              </a:r>
            </a:p>
          </p:txBody>
        </p:sp>
      </p:grpSp>
      <p:sp>
        <p:nvSpPr>
          <p:cNvPr id="11" name="textruta 10">
            <a:extLst>
              <a:ext uri="{FF2B5EF4-FFF2-40B4-BE49-F238E27FC236}">
                <a16:creationId xmlns:a16="http://schemas.microsoft.com/office/drawing/2014/main" id="{67B80BB0-9577-35DC-9F0E-53DB27DF2ABF}"/>
              </a:ext>
            </a:extLst>
          </p:cNvPr>
          <p:cNvSpPr txBox="1"/>
          <p:nvPr/>
        </p:nvSpPr>
        <p:spPr>
          <a:xfrm>
            <a:off x="844855" y="136737"/>
            <a:ext cx="501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dditional file 7. Balance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apacity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with CI on and off in NVF and VL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3021202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objekt 6" descr="En bild som visar text, diagram, skärmbild, linje">
            <a:extLst>
              <a:ext uri="{FF2B5EF4-FFF2-40B4-BE49-F238E27FC236}">
                <a16:creationId xmlns:a16="http://schemas.microsoft.com/office/drawing/2014/main" id="{BBB097DB-9047-4498-D279-C3B4678B4D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9182" y="3231490"/>
            <a:ext cx="4176054" cy="2770603"/>
          </a:xfrm>
          <a:prstGeom prst="rect">
            <a:avLst/>
          </a:prstGeom>
        </p:spPr>
      </p:pic>
      <p:pic>
        <p:nvPicPr>
          <p:cNvPr id="13" name="Bildobjekt 12" descr="En bild som visar text, skärmbild, diagram, Graf">
            <a:extLst>
              <a:ext uri="{FF2B5EF4-FFF2-40B4-BE49-F238E27FC236}">
                <a16:creationId xmlns:a16="http://schemas.microsoft.com/office/drawing/2014/main" id="{F69A4660-A817-322A-06D7-78B03C7930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02600" y="3215185"/>
            <a:ext cx="4756382" cy="3075004"/>
          </a:xfrm>
          <a:prstGeom prst="rect">
            <a:avLst/>
          </a:prstGeom>
        </p:spPr>
      </p:pic>
      <p:pic>
        <p:nvPicPr>
          <p:cNvPr id="30" name="Bildobjekt 29" descr="En bild som visar text, diagram, skärmbild, linje">
            <a:extLst>
              <a:ext uri="{FF2B5EF4-FFF2-40B4-BE49-F238E27FC236}">
                <a16:creationId xmlns:a16="http://schemas.microsoft.com/office/drawing/2014/main" id="{19CBC027-67C2-5582-21BC-53EBF66D1D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36339" y="407162"/>
            <a:ext cx="4556165" cy="2947471"/>
          </a:xfrm>
          <a:prstGeom prst="rect">
            <a:avLst/>
          </a:prstGeom>
        </p:spPr>
      </p:pic>
      <p:pic>
        <p:nvPicPr>
          <p:cNvPr id="22" name="Bildobjekt 21" descr="En bild som visar text, diagram, skärmbild, linje">
            <a:extLst>
              <a:ext uri="{FF2B5EF4-FFF2-40B4-BE49-F238E27FC236}">
                <a16:creationId xmlns:a16="http://schemas.microsoft.com/office/drawing/2014/main" id="{80CC697F-7B9D-4404-5C55-0EC6042484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0966" y="220062"/>
            <a:ext cx="4435262" cy="3079459"/>
          </a:xfrm>
          <a:prstGeom prst="rect">
            <a:avLst/>
          </a:prstGeom>
        </p:spPr>
      </p:pic>
      <p:sp>
        <p:nvSpPr>
          <p:cNvPr id="12" name="textruta 11">
            <a:extLst>
              <a:ext uri="{FF2B5EF4-FFF2-40B4-BE49-F238E27FC236}">
                <a16:creationId xmlns:a16="http://schemas.microsoft.com/office/drawing/2014/main" id="{73AD1CC8-E231-00B8-281B-9D506F7C756B}"/>
              </a:ext>
            </a:extLst>
          </p:cNvPr>
          <p:cNvSpPr txBox="1"/>
          <p:nvPr/>
        </p:nvSpPr>
        <p:spPr>
          <a:xfrm>
            <a:off x="1896802" y="5761922"/>
            <a:ext cx="83983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alance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acity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ith Cochlear Implants (CI) on and off in vestibular subgroups: teenagers and young adults 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GB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earing (NH)</a:t>
            </a:r>
            <a:r>
              <a:rPr lang="en-GB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=20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with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chlear implants and 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 vestibular function (CI-NVF), n=19, with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chlear implants and 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lateral vestibular </a:t>
            </a:r>
            <a:r>
              <a:rPr lang="en-GB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irment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I-UVI), n=5, and with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chlear implants and 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lateral vestibular </a:t>
            </a:r>
            <a:r>
              <a:rPr lang="en-GB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airment</a:t>
            </a:r>
            <a:r>
              <a:rPr lang="en-GB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I-BVI), n=13, 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a) item BOT4 from </a:t>
            </a:r>
            <a:r>
              <a:rPr kumimoji="0" lang="en-GB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uininks-Oseretsky Test of Motor Proficiency (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OT-2), b) item BOT6 from BOT-2, c) item BOT9 from BOT-2 and d) item 19d from 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ds-</a:t>
            </a:r>
            <a:r>
              <a:rPr kumimoji="0" lang="sv-SE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ance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valuation System Test</a:t>
            </a:r>
            <a:r>
              <a:rPr kumimoji="0" lang="sv-SE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ids-</a:t>
            </a:r>
            <a:r>
              <a:rPr kumimoji="0" lang="sv-S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ESTest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Time in seconds.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sv-S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8" name="Vänster hakparentes 7">
            <a:extLst>
              <a:ext uri="{FF2B5EF4-FFF2-40B4-BE49-F238E27FC236}">
                <a16:creationId xmlns:a16="http://schemas.microsoft.com/office/drawing/2014/main" id="{8604688D-3970-7F65-DE47-359547E3FB42}"/>
              </a:ext>
            </a:extLst>
          </p:cNvPr>
          <p:cNvSpPr/>
          <p:nvPr/>
        </p:nvSpPr>
        <p:spPr>
          <a:xfrm rot="5400000">
            <a:off x="1638043" y="2690685"/>
            <a:ext cx="126474" cy="803567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Vänster hakparentes 15">
            <a:extLst>
              <a:ext uri="{FF2B5EF4-FFF2-40B4-BE49-F238E27FC236}">
                <a16:creationId xmlns:a16="http://schemas.microsoft.com/office/drawing/2014/main" id="{818BDFB5-C90E-FC7F-84B4-F401F0CE61CC}"/>
              </a:ext>
            </a:extLst>
          </p:cNvPr>
          <p:cNvSpPr/>
          <p:nvPr/>
        </p:nvSpPr>
        <p:spPr>
          <a:xfrm rot="5400000">
            <a:off x="1964218" y="2363654"/>
            <a:ext cx="104422" cy="1435577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20" name="Grupp 19">
            <a:extLst>
              <a:ext uri="{FF2B5EF4-FFF2-40B4-BE49-F238E27FC236}">
                <a16:creationId xmlns:a16="http://schemas.microsoft.com/office/drawing/2014/main" id="{882B9C89-EC14-9B37-A02C-A471F0598F73}"/>
              </a:ext>
            </a:extLst>
          </p:cNvPr>
          <p:cNvGrpSpPr/>
          <p:nvPr/>
        </p:nvGrpSpPr>
        <p:grpSpPr>
          <a:xfrm>
            <a:off x="1178352" y="2836568"/>
            <a:ext cx="2425434" cy="456507"/>
            <a:chOff x="1107141" y="3245829"/>
            <a:chExt cx="2424945" cy="501962"/>
          </a:xfrm>
        </p:grpSpPr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2B464B23-1968-BA25-6C61-13529DEEA95B}"/>
                </a:ext>
              </a:extLst>
            </p:cNvPr>
            <p:cNvSpPr txBox="1"/>
            <p:nvPr/>
          </p:nvSpPr>
          <p:spPr>
            <a:xfrm>
              <a:off x="1165412" y="3245829"/>
              <a:ext cx="600632" cy="381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***</a:t>
              </a:r>
            </a:p>
          </p:txBody>
        </p:sp>
        <p:grpSp>
          <p:nvGrpSpPr>
            <p:cNvPr id="2" name="Grupp 1">
              <a:extLst>
                <a:ext uri="{FF2B5EF4-FFF2-40B4-BE49-F238E27FC236}">
                  <a16:creationId xmlns:a16="http://schemas.microsoft.com/office/drawing/2014/main" id="{F51F18E9-9951-5A49-DB5C-69F42FF16C47}"/>
                </a:ext>
              </a:extLst>
            </p:cNvPr>
            <p:cNvGrpSpPr/>
            <p:nvPr/>
          </p:nvGrpSpPr>
          <p:grpSpPr>
            <a:xfrm>
              <a:off x="1107141" y="3438883"/>
              <a:ext cx="2424945" cy="308908"/>
              <a:chOff x="1107141" y="3438883"/>
              <a:chExt cx="2424945" cy="308908"/>
            </a:xfrm>
          </p:grpSpPr>
          <p:sp>
            <p:nvSpPr>
              <p:cNvPr id="4" name="Vänster hakparentes 3">
                <a:extLst>
                  <a:ext uri="{FF2B5EF4-FFF2-40B4-BE49-F238E27FC236}">
                    <a16:creationId xmlns:a16="http://schemas.microsoft.com/office/drawing/2014/main" id="{FD7A127F-19DB-F4C5-A043-707917F80728}"/>
                  </a:ext>
                </a:extLst>
              </p:cNvPr>
              <p:cNvSpPr/>
              <p:nvPr/>
            </p:nvSpPr>
            <p:spPr>
              <a:xfrm rot="5400000">
                <a:off x="1227680" y="3500778"/>
                <a:ext cx="126474" cy="367552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Vänster hakparentes 14">
                <a:extLst>
                  <a:ext uri="{FF2B5EF4-FFF2-40B4-BE49-F238E27FC236}">
                    <a16:creationId xmlns:a16="http://schemas.microsoft.com/office/drawing/2014/main" id="{4A98E9C3-C71E-F097-BFD9-85D3E40517EC}"/>
                  </a:ext>
                </a:extLst>
              </p:cNvPr>
              <p:cNvSpPr/>
              <p:nvPr/>
            </p:nvSpPr>
            <p:spPr>
              <a:xfrm rot="5400000">
                <a:off x="1944853" y="3496298"/>
                <a:ext cx="126474" cy="367552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" name="Vänster hakparentes 16">
                <a:extLst>
                  <a:ext uri="{FF2B5EF4-FFF2-40B4-BE49-F238E27FC236}">
                    <a16:creationId xmlns:a16="http://schemas.microsoft.com/office/drawing/2014/main" id="{13E0A82B-F713-61FF-3E5A-CD311EA64AD2}"/>
                  </a:ext>
                </a:extLst>
              </p:cNvPr>
              <p:cNvSpPr/>
              <p:nvPr/>
            </p:nvSpPr>
            <p:spPr>
              <a:xfrm rot="5400000">
                <a:off x="2206458" y="2459368"/>
                <a:ext cx="157861" cy="2116892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Vänster hakparentes 17">
                <a:extLst>
                  <a:ext uri="{FF2B5EF4-FFF2-40B4-BE49-F238E27FC236}">
                    <a16:creationId xmlns:a16="http://schemas.microsoft.com/office/drawing/2014/main" id="{CE5D61AF-862D-69CF-A729-43B8330AAACC}"/>
                  </a:ext>
                </a:extLst>
              </p:cNvPr>
              <p:cNvSpPr/>
              <p:nvPr/>
            </p:nvSpPr>
            <p:spPr>
              <a:xfrm rot="5400000">
                <a:off x="2603756" y="3487332"/>
                <a:ext cx="126474" cy="367552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Vänster hakparentes 18">
                <a:extLst>
                  <a:ext uri="{FF2B5EF4-FFF2-40B4-BE49-F238E27FC236}">
                    <a16:creationId xmlns:a16="http://schemas.microsoft.com/office/drawing/2014/main" id="{9EDC3057-4D0D-1ACA-AC35-C353D5F01ABA}"/>
                  </a:ext>
                </a:extLst>
              </p:cNvPr>
              <p:cNvSpPr/>
              <p:nvPr/>
            </p:nvSpPr>
            <p:spPr>
              <a:xfrm rot="5400000">
                <a:off x="3285073" y="3478369"/>
                <a:ext cx="126474" cy="367552"/>
              </a:xfrm>
              <a:prstGeom prst="leftBracket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24" name="textruta 23">
            <a:extLst>
              <a:ext uri="{FF2B5EF4-FFF2-40B4-BE49-F238E27FC236}">
                <a16:creationId xmlns:a16="http://schemas.microsoft.com/office/drawing/2014/main" id="{981FDD75-1106-6C2D-797C-2BD8EF5B915A}"/>
              </a:ext>
            </a:extLst>
          </p:cNvPr>
          <p:cNvSpPr txBox="1"/>
          <p:nvPr/>
        </p:nvSpPr>
        <p:spPr>
          <a:xfrm>
            <a:off x="263951" y="268663"/>
            <a:ext cx="367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25" name="textruta 24">
            <a:extLst>
              <a:ext uri="{FF2B5EF4-FFF2-40B4-BE49-F238E27FC236}">
                <a16:creationId xmlns:a16="http://schemas.microsoft.com/office/drawing/2014/main" id="{362D7477-3D3A-8315-731C-492367EDE774}"/>
              </a:ext>
            </a:extLst>
          </p:cNvPr>
          <p:cNvSpPr txBox="1"/>
          <p:nvPr/>
        </p:nvSpPr>
        <p:spPr>
          <a:xfrm>
            <a:off x="5838009" y="270609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26" name="textruta 25">
            <a:extLst>
              <a:ext uri="{FF2B5EF4-FFF2-40B4-BE49-F238E27FC236}">
                <a16:creationId xmlns:a16="http://schemas.microsoft.com/office/drawing/2014/main" id="{666C905E-E9E5-55F4-B656-E4A003E35689}"/>
              </a:ext>
            </a:extLst>
          </p:cNvPr>
          <p:cNvSpPr txBox="1"/>
          <p:nvPr/>
        </p:nvSpPr>
        <p:spPr>
          <a:xfrm>
            <a:off x="277891" y="2993668"/>
            <a:ext cx="367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27" name="textruta 26">
            <a:extLst>
              <a:ext uri="{FF2B5EF4-FFF2-40B4-BE49-F238E27FC236}">
                <a16:creationId xmlns:a16="http://schemas.microsoft.com/office/drawing/2014/main" id="{CDC9F622-5EDA-8B8E-2F0F-448BAED3FFD5}"/>
              </a:ext>
            </a:extLst>
          </p:cNvPr>
          <p:cNvSpPr txBox="1"/>
          <p:nvPr/>
        </p:nvSpPr>
        <p:spPr>
          <a:xfrm>
            <a:off x="5895585" y="3097535"/>
            <a:ext cx="367552" cy="2771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sp>
        <p:nvSpPr>
          <p:cNvPr id="3" name="textruta 2">
            <a:extLst>
              <a:ext uri="{FF2B5EF4-FFF2-40B4-BE49-F238E27FC236}">
                <a16:creationId xmlns:a16="http://schemas.microsoft.com/office/drawing/2014/main" id="{BB3E10A2-D3DF-1452-151F-D32787E36CA1}"/>
              </a:ext>
            </a:extLst>
          </p:cNvPr>
          <p:cNvSpPr txBox="1"/>
          <p:nvPr/>
        </p:nvSpPr>
        <p:spPr>
          <a:xfrm>
            <a:off x="567859" y="-14286"/>
            <a:ext cx="6071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dditional file 8. Balance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apacity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with CI on and off in NH, CI-NVF, CI-UVI and CI-BVI 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3633357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665</Words>
  <Application>Microsoft Office PowerPoint</Application>
  <PresentationFormat>Bredbild</PresentationFormat>
  <Paragraphs>52</Paragraphs>
  <Slides>5</Slides>
  <Notes>5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Times New Roman</vt:lpstr>
      <vt:lpstr>Office-tema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Susanne Gripenberg</dc:creator>
  <cp:lastModifiedBy>Susanne Gripenberg</cp:lastModifiedBy>
  <cp:revision>1</cp:revision>
  <dcterms:created xsi:type="dcterms:W3CDTF">2025-11-23T09:57:07Z</dcterms:created>
  <dcterms:modified xsi:type="dcterms:W3CDTF">2026-01-29T20:03:20Z</dcterms:modified>
</cp:coreProperties>
</file>